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3D36B-437C-7F7F-957E-3125685C5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5D7ED5-0C67-F624-B06E-3AAC860D61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6BFDB-BCE2-D838-E42C-70FCCA1C7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A55063-1B1F-298E-D639-38A4F92B2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9A647B-B594-E804-FBA2-B5FB0FA87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209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8B514-7843-8221-07AD-EE4AA7E2F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25A50C-AD89-0502-EC5E-163CA5D06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C892F-B0FE-665B-8BF8-A6E4E7FAD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C33325-33D3-A026-A23F-7B9B01C78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7D311-1D29-FC62-FB1A-404843D0E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72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066BCD-C06E-07D1-FB76-297CE0E361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744A28-4222-92FC-4563-B8650A0B66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773884-C101-9A82-C2DD-F4E241B07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ABC5D-93E0-2BC4-7779-4A5559023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A7ECA-3981-60E6-849C-B86DDB0C4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18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7D024B-6F48-8836-D86E-D4FECE270E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333F9F-2579-5050-96BD-0A355D0E29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57AB5-50F1-F2AD-E196-B84ED6239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9F3DA6-2898-ECDB-BB96-E53CD7972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5B599-BC3E-E3B3-06A6-2CB381628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498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0B590D-BCDC-38AE-1F9E-7283806A3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7AE35C-8F1E-40A1-224C-97D4EFD396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42891-4633-F84C-740D-98183DBDC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AC58B4-4018-8683-72B7-811DA9AD2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5D842-32FF-05EB-A416-CB10AACB3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5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4DCEF7-FCDE-72F2-F2FE-108711CBAD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1C2EE0-8ED4-14A1-3167-53253E5590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4693F7-6A5B-0EDA-C92A-A131BB2036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E3F69-F2AE-F2CD-9852-727308EC1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A475BF-34F6-0286-A95E-A381725F0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986242-D3B3-1BB7-E1AA-49052A1F3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12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74017-4677-FD50-ABDC-5A23786E8C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C4AC36-EF6A-565D-6F4F-721C7967C4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B08314-2C57-533A-674A-53C623BC8C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1E6794-B208-DA06-4623-632D00567B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A8F557D-30BB-9736-36B6-BEB36858C1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ECD153-0F2E-511C-CD07-BE107217F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E0E833-9826-B37F-FF8C-920FA996D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D0A516-7EC3-3F38-AB31-ED58B359B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14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B03E8-D4C0-D35F-B16E-CD2C8F282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5B9448-5D15-B1C6-C49F-2568514DA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BC7707-7F31-C729-50CA-CBC376381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3FB6FE-EE57-C675-06DF-CE24ECE1B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24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7B07F9-3484-0AF6-0D6A-5FC1C279B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5675F8-A9FA-702E-F559-6B13D541C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682303-0878-6395-B3BE-4FD7A6BE6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72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C2BED-B46C-B689-E6F6-820F53BE4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0E49BE-C77A-1885-AAC7-A0A7C73970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DD71C7-A35C-5113-33C0-9AA9C9DB8D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080AD7-1B53-99B2-3629-03F2340B8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84974D-090B-D098-E8EA-6A2866FF6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C00BB6-B86C-15E8-0C5C-51606D1E6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717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4A787-D8EC-5151-B152-E4C77175C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933446-C91F-4D45-0611-02EB0E5742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4DE224-817C-317B-4CD3-5734D5FEB2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75F833-AD66-DF98-BF94-ADD9A94FF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560EBA-DC71-76BE-E834-624638A70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2E2289-6241-DFBE-E4F7-C36C5A785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35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68BE1C-EE85-660D-4767-B3C788BE8F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9355C2-4940-2CEC-C305-A392509E68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AE55A-59F9-AED5-6315-D5D35B0B1A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CD8F0-E9B8-C14B-B27E-CC175D22ACCC}" type="datetimeFigureOut">
              <a:rPr lang="en-US" smtClean="0"/>
              <a:t>7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B83F9B-55E6-F1B0-EAC9-493B10D12E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2479B8-F9AD-F8F7-7783-5AA12BAB08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DDF53-55D0-FD46-95DD-7BC6A28211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841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E2E1D-5F8A-0025-469D-0DDE688DE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1142998"/>
          </a:xfrm>
        </p:spPr>
        <p:txBody>
          <a:bodyPr>
            <a:normAutofit/>
          </a:bodyPr>
          <a:lstStyle/>
          <a:p>
            <a:r>
              <a:rPr lang="en-US" sz="2000" b="1" dirty="0"/>
              <a:t>Supplementary Figure S1. </a:t>
            </a:r>
            <a:r>
              <a:rPr lang="en-US" sz="2000" dirty="0"/>
              <a:t>Enrichment of ER+ breast cancer genes for </a:t>
            </a:r>
            <a:r>
              <a:rPr lang="en-US" sz="2000" dirty="0" err="1"/>
              <a:t>GTEx</a:t>
            </a:r>
            <a:r>
              <a:rPr lang="en-US" sz="2000" dirty="0"/>
              <a:t> tissues.</a:t>
            </a:r>
          </a:p>
        </p:txBody>
      </p:sp>
      <p:pic>
        <p:nvPicPr>
          <p:cNvPr id="5" name="Picture 4" descr="A picture containing diagram, line, plot, font&#10;&#10;Description automatically generated">
            <a:extLst>
              <a:ext uri="{FF2B5EF4-FFF2-40B4-BE49-F238E27FC236}">
                <a16:creationId xmlns:a16="http://schemas.microsoft.com/office/drawing/2014/main" id="{7FD3ED99-311C-838E-86CD-0CC4582575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142999"/>
            <a:ext cx="5334000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901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E2E1D-5F8A-0025-469D-0DDE688DE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"/>
            <a:ext cx="10515600" cy="1142998"/>
          </a:xfrm>
        </p:spPr>
        <p:txBody>
          <a:bodyPr>
            <a:normAutofit/>
          </a:bodyPr>
          <a:lstStyle/>
          <a:p>
            <a:r>
              <a:rPr lang="en-US" sz="2000" b="1" dirty="0"/>
              <a:t>Supplementary Figure S2. </a:t>
            </a:r>
            <a:r>
              <a:rPr lang="en-US" sz="2000" dirty="0"/>
              <a:t>Enrichment of ER- breast cancer genes for </a:t>
            </a:r>
            <a:r>
              <a:rPr lang="en-US" sz="2000" dirty="0" err="1"/>
              <a:t>GTEx</a:t>
            </a:r>
            <a:r>
              <a:rPr lang="en-US" sz="2000" dirty="0"/>
              <a:t> tissues.</a:t>
            </a:r>
          </a:p>
        </p:txBody>
      </p:sp>
      <p:pic>
        <p:nvPicPr>
          <p:cNvPr id="5" name="Picture 4" descr="A picture containing diagram, text, line, plot&#10;&#10;Description automatically generated">
            <a:extLst>
              <a:ext uri="{FF2B5EF4-FFF2-40B4-BE49-F238E27FC236}">
                <a16:creationId xmlns:a16="http://schemas.microsoft.com/office/drawing/2014/main" id="{F16E9098-AF36-E596-7930-AD63FA16B9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142999"/>
            <a:ext cx="5334000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2904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Figure S1. Enrichment of ER+ breast cancer genes for GTEx tissues.</vt:lpstr>
      <vt:lpstr>Supplementary Figure S2. Enrichment of ER- breast cancer genes for GTEx tissues.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S1. Enrichment of ER+ breast cancer genes for GTEx tissues.</dc:title>
  <dc:subject/>
  <dc:creator/>
  <cp:keywords/>
  <dc:description/>
  <cp:lastModifiedBy>James Li</cp:lastModifiedBy>
  <cp:revision>2</cp:revision>
  <dcterms:created xsi:type="dcterms:W3CDTF">2023-07-02T16:50:45Z</dcterms:created>
  <dcterms:modified xsi:type="dcterms:W3CDTF">2023-07-03T00:46:08Z</dcterms:modified>
  <cp:category/>
</cp:coreProperties>
</file>